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F94895-2959-4D30-8D70-FBE2D2D78D5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BF6607-615F-44F3-A923-CB63EDB3C84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BD9AA8-2BCB-4D4F-96DA-5ECDA484BD1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B53D27-B08E-4F0D-B1A8-A0C80C8F354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867C18-FA4E-4770-9C8C-9137950FF3D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44BEBF-83C8-4F75-B880-DF1D98F275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CBAE09-8F3A-4921-B61F-C268041CBB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6ED348-5165-46CE-83AD-E564FA2E13B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0C2F06-8557-4940-B43B-06CDA415D3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28A70F-637B-4227-9A27-A8FD136428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EE1E2B-F428-4D76-A883-B59DB3A406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97BD04-89AB-4B3B-B2A4-CDD68BB06D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86A67F3-3A04-4C7C-8AAA-E1A8FEBEFA09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Line 10"/>
          <p:cNvSpPr/>
          <p:nvPr/>
        </p:nvSpPr>
        <p:spPr>
          <a:xfrm>
            <a:off x="2903400" y="4275000"/>
            <a:ext cx="27752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Line 11"/>
          <p:cNvSpPr/>
          <p:nvPr/>
        </p:nvSpPr>
        <p:spPr>
          <a:xfrm>
            <a:off x="2997360" y="4275000"/>
            <a:ext cx="0" cy="4788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Line 12"/>
          <p:cNvSpPr/>
          <p:nvPr/>
        </p:nvSpPr>
        <p:spPr>
          <a:xfrm>
            <a:off x="3514680" y="4275000"/>
            <a:ext cx="0" cy="4788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13"/>
          <p:cNvSpPr/>
          <p:nvPr/>
        </p:nvSpPr>
        <p:spPr>
          <a:xfrm>
            <a:off x="4032360" y="4275000"/>
            <a:ext cx="0" cy="4788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Line 14"/>
          <p:cNvSpPr/>
          <p:nvPr/>
        </p:nvSpPr>
        <p:spPr>
          <a:xfrm>
            <a:off x="4549680" y="4275000"/>
            <a:ext cx="0" cy="4788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15"/>
          <p:cNvSpPr/>
          <p:nvPr/>
        </p:nvSpPr>
        <p:spPr>
          <a:xfrm>
            <a:off x="5067360" y="4275000"/>
            <a:ext cx="0" cy="4788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16"/>
          <p:cNvSpPr/>
          <p:nvPr/>
        </p:nvSpPr>
        <p:spPr>
          <a:xfrm>
            <a:off x="5584680" y="4275000"/>
            <a:ext cx="0" cy="4788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24"/>
          <p:cNvSpPr/>
          <p:nvPr/>
        </p:nvSpPr>
        <p:spPr>
          <a:xfrm>
            <a:off x="2903400" y="1687680"/>
            <a:ext cx="0" cy="258732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25"/>
          <p:cNvSpPr/>
          <p:nvPr/>
        </p:nvSpPr>
        <p:spPr>
          <a:xfrm flipH="1">
            <a:off x="2854440" y="4275000"/>
            <a:ext cx="489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26"/>
          <p:cNvSpPr/>
          <p:nvPr/>
        </p:nvSpPr>
        <p:spPr>
          <a:xfrm flipH="1">
            <a:off x="2854440" y="3755880"/>
            <a:ext cx="489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27"/>
          <p:cNvSpPr/>
          <p:nvPr/>
        </p:nvSpPr>
        <p:spPr>
          <a:xfrm flipH="1">
            <a:off x="2854440" y="3238560"/>
            <a:ext cx="489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28"/>
          <p:cNvSpPr/>
          <p:nvPr/>
        </p:nvSpPr>
        <p:spPr>
          <a:xfrm flipH="1">
            <a:off x="2854440" y="2722680"/>
            <a:ext cx="489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29"/>
          <p:cNvSpPr/>
          <p:nvPr/>
        </p:nvSpPr>
        <p:spPr>
          <a:xfrm flipH="1">
            <a:off x="2854440" y="2205000"/>
            <a:ext cx="489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30"/>
          <p:cNvSpPr/>
          <p:nvPr/>
        </p:nvSpPr>
        <p:spPr>
          <a:xfrm flipH="1">
            <a:off x="2854440" y="1687680"/>
            <a:ext cx="489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Freeform 38"/>
          <p:cNvSpPr/>
          <p:nvPr/>
        </p:nvSpPr>
        <p:spPr>
          <a:xfrm>
            <a:off x="2997360" y="1687680"/>
            <a:ext cx="2587320" cy="2587320"/>
          </a:xfrm>
          <a:custGeom>
            <a:avLst/>
            <a:gdLst/>
            <a:ahLst/>
            <a:rect l="l" t="t" r="r" b="b"/>
            <a:pathLst>
              <a:path w="1630" h="1630">
                <a:moveTo>
                  <a:pt x="1630" y="0"/>
                </a:moveTo>
                <a:lnTo>
                  <a:pt x="994" y="233"/>
                </a:lnTo>
                <a:lnTo>
                  <a:pt x="954" y="233"/>
                </a:lnTo>
                <a:lnTo>
                  <a:pt x="954" y="279"/>
                </a:lnTo>
                <a:lnTo>
                  <a:pt x="954" y="326"/>
                </a:lnTo>
                <a:lnTo>
                  <a:pt x="954" y="372"/>
                </a:lnTo>
                <a:lnTo>
                  <a:pt x="954" y="512"/>
                </a:lnTo>
                <a:lnTo>
                  <a:pt x="914" y="512"/>
                </a:lnTo>
                <a:lnTo>
                  <a:pt x="914" y="559"/>
                </a:lnTo>
                <a:lnTo>
                  <a:pt x="875" y="559"/>
                </a:lnTo>
                <a:lnTo>
                  <a:pt x="835" y="559"/>
                </a:lnTo>
                <a:lnTo>
                  <a:pt x="835" y="605"/>
                </a:lnTo>
                <a:lnTo>
                  <a:pt x="795" y="605"/>
                </a:lnTo>
                <a:lnTo>
                  <a:pt x="755" y="605"/>
                </a:lnTo>
                <a:lnTo>
                  <a:pt x="716" y="652"/>
                </a:lnTo>
                <a:lnTo>
                  <a:pt x="716" y="698"/>
                </a:lnTo>
                <a:lnTo>
                  <a:pt x="716" y="745"/>
                </a:lnTo>
                <a:lnTo>
                  <a:pt x="676" y="745"/>
                </a:lnTo>
                <a:lnTo>
                  <a:pt x="636" y="745"/>
                </a:lnTo>
                <a:lnTo>
                  <a:pt x="596" y="745"/>
                </a:lnTo>
                <a:lnTo>
                  <a:pt x="557" y="745"/>
                </a:lnTo>
                <a:lnTo>
                  <a:pt x="517" y="791"/>
                </a:lnTo>
                <a:lnTo>
                  <a:pt x="477" y="791"/>
                </a:lnTo>
                <a:lnTo>
                  <a:pt x="477" y="838"/>
                </a:lnTo>
                <a:lnTo>
                  <a:pt x="437" y="838"/>
                </a:lnTo>
                <a:lnTo>
                  <a:pt x="437" y="884"/>
                </a:lnTo>
                <a:lnTo>
                  <a:pt x="437" y="977"/>
                </a:lnTo>
                <a:lnTo>
                  <a:pt x="437" y="1024"/>
                </a:lnTo>
                <a:lnTo>
                  <a:pt x="437" y="1071"/>
                </a:lnTo>
                <a:lnTo>
                  <a:pt x="398" y="1071"/>
                </a:lnTo>
                <a:lnTo>
                  <a:pt x="318" y="1071"/>
                </a:lnTo>
                <a:lnTo>
                  <a:pt x="278" y="1071"/>
                </a:lnTo>
                <a:lnTo>
                  <a:pt x="239" y="1071"/>
                </a:lnTo>
                <a:lnTo>
                  <a:pt x="199" y="1071"/>
                </a:lnTo>
                <a:lnTo>
                  <a:pt x="159" y="1071"/>
                </a:lnTo>
                <a:lnTo>
                  <a:pt x="159" y="1117"/>
                </a:lnTo>
                <a:lnTo>
                  <a:pt x="159" y="1164"/>
                </a:lnTo>
                <a:lnTo>
                  <a:pt x="159" y="1210"/>
                </a:lnTo>
                <a:lnTo>
                  <a:pt x="119" y="1210"/>
                </a:lnTo>
                <a:lnTo>
                  <a:pt x="119" y="1257"/>
                </a:lnTo>
                <a:lnTo>
                  <a:pt x="80" y="1257"/>
                </a:lnTo>
                <a:lnTo>
                  <a:pt x="80" y="1303"/>
                </a:lnTo>
                <a:lnTo>
                  <a:pt x="40" y="1303"/>
                </a:lnTo>
                <a:lnTo>
                  <a:pt x="0" y="1303"/>
                </a:lnTo>
                <a:lnTo>
                  <a:pt x="0" y="1350"/>
                </a:lnTo>
                <a:lnTo>
                  <a:pt x="0" y="1397"/>
                </a:lnTo>
                <a:lnTo>
                  <a:pt x="0" y="1443"/>
                </a:lnTo>
                <a:lnTo>
                  <a:pt x="0" y="1490"/>
                </a:lnTo>
                <a:lnTo>
                  <a:pt x="0" y="1536"/>
                </a:lnTo>
                <a:lnTo>
                  <a:pt x="0" y="1583"/>
                </a:lnTo>
                <a:lnTo>
                  <a:pt x="0" y="1630"/>
                </a:lnTo>
              </a:path>
            </a:pathLst>
          </a:custGeom>
          <a:noFill/>
          <a:ln w="15840">
            <a:solidFill>
              <a:srgbClr val="3e58a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Freeform 39"/>
          <p:cNvSpPr/>
          <p:nvPr/>
        </p:nvSpPr>
        <p:spPr>
          <a:xfrm>
            <a:off x="2997360" y="1687680"/>
            <a:ext cx="2587320" cy="2587320"/>
          </a:xfrm>
          <a:custGeom>
            <a:avLst/>
            <a:gdLst/>
            <a:ahLst/>
            <a:rect l="l" t="t" r="r" b="b"/>
            <a:pathLst>
              <a:path w="1630" h="1630">
                <a:moveTo>
                  <a:pt x="1630" y="0"/>
                </a:moveTo>
                <a:lnTo>
                  <a:pt x="1630" y="46"/>
                </a:lnTo>
                <a:lnTo>
                  <a:pt x="1590" y="46"/>
                </a:lnTo>
                <a:lnTo>
                  <a:pt x="1510" y="46"/>
                </a:lnTo>
                <a:lnTo>
                  <a:pt x="1351" y="46"/>
                </a:lnTo>
                <a:lnTo>
                  <a:pt x="1312" y="93"/>
                </a:lnTo>
                <a:lnTo>
                  <a:pt x="1193" y="140"/>
                </a:lnTo>
                <a:lnTo>
                  <a:pt x="994" y="186"/>
                </a:lnTo>
                <a:lnTo>
                  <a:pt x="994" y="233"/>
                </a:lnTo>
                <a:lnTo>
                  <a:pt x="954" y="279"/>
                </a:lnTo>
                <a:lnTo>
                  <a:pt x="875" y="326"/>
                </a:lnTo>
                <a:lnTo>
                  <a:pt x="835" y="419"/>
                </a:lnTo>
                <a:lnTo>
                  <a:pt x="716" y="512"/>
                </a:lnTo>
                <a:lnTo>
                  <a:pt x="636" y="559"/>
                </a:lnTo>
                <a:lnTo>
                  <a:pt x="557" y="745"/>
                </a:lnTo>
                <a:lnTo>
                  <a:pt x="437" y="884"/>
                </a:lnTo>
                <a:lnTo>
                  <a:pt x="398" y="931"/>
                </a:lnTo>
                <a:lnTo>
                  <a:pt x="318" y="977"/>
                </a:lnTo>
                <a:lnTo>
                  <a:pt x="278" y="1117"/>
                </a:lnTo>
                <a:lnTo>
                  <a:pt x="239" y="1117"/>
                </a:lnTo>
                <a:lnTo>
                  <a:pt x="159" y="1164"/>
                </a:lnTo>
                <a:lnTo>
                  <a:pt x="119" y="1257"/>
                </a:lnTo>
                <a:lnTo>
                  <a:pt x="119" y="1303"/>
                </a:lnTo>
                <a:lnTo>
                  <a:pt x="119" y="1350"/>
                </a:lnTo>
                <a:lnTo>
                  <a:pt x="119" y="1490"/>
                </a:lnTo>
                <a:lnTo>
                  <a:pt x="119" y="1536"/>
                </a:lnTo>
                <a:lnTo>
                  <a:pt x="40" y="1536"/>
                </a:lnTo>
                <a:lnTo>
                  <a:pt x="40" y="1583"/>
                </a:lnTo>
                <a:lnTo>
                  <a:pt x="0" y="1583"/>
                </a:lnTo>
                <a:lnTo>
                  <a:pt x="0" y="1630"/>
                </a:lnTo>
              </a:path>
            </a:pathLst>
          </a:custGeom>
          <a:noFill/>
          <a:ln w="15840">
            <a:solidFill>
              <a:srgbClr val="2eb84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Freeform 40"/>
          <p:cNvSpPr/>
          <p:nvPr/>
        </p:nvSpPr>
        <p:spPr>
          <a:xfrm>
            <a:off x="2997360" y="1687680"/>
            <a:ext cx="2587320" cy="2587320"/>
          </a:xfrm>
          <a:custGeom>
            <a:avLst/>
            <a:gdLst/>
            <a:ahLst/>
            <a:rect l="l" t="t" r="r" b="b"/>
            <a:pathLst>
              <a:path w="1630" h="1630">
                <a:moveTo>
                  <a:pt x="1630" y="0"/>
                </a:moveTo>
                <a:lnTo>
                  <a:pt x="1630" y="46"/>
                </a:lnTo>
                <a:lnTo>
                  <a:pt x="1630" y="93"/>
                </a:lnTo>
                <a:lnTo>
                  <a:pt x="1550" y="93"/>
                </a:lnTo>
                <a:lnTo>
                  <a:pt x="1550" y="140"/>
                </a:lnTo>
                <a:lnTo>
                  <a:pt x="1471" y="186"/>
                </a:lnTo>
                <a:lnTo>
                  <a:pt x="1431" y="186"/>
                </a:lnTo>
                <a:lnTo>
                  <a:pt x="1351" y="279"/>
                </a:lnTo>
                <a:lnTo>
                  <a:pt x="1351" y="326"/>
                </a:lnTo>
                <a:lnTo>
                  <a:pt x="1272" y="372"/>
                </a:lnTo>
                <a:lnTo>
                  <a:pt x="1113" y="419"/>
                </a:lnTo>
                <a:lnTo>
                  <a:pt x="1034" y="419"/>
                </a:lnTo>
                <a:lnTo>
                  <a:pt x="875" y="465"/>
                </a:lnTo>
                <a:lnTo>
                  <a:pt x="875" y="512"/>
                </a:lnTo>
                <a:lnTo>
                  <a:pt x="875" y="559"/>
                </a:lnTo>
                <a:lnTo>
                  <a:pt x="835" y="559"/>
                </a:lnTo>
                <a:lnTo>
                  <a:pt x="795" y="652"/>
                </a:lnTo>
                <a:lnTo>
                  <a:pt x="795" y="698"/>
                </a:lnTo>
                <a:lnTo>
                  <a:pt x="755" y="698"/>
                </a:lnTo>
                <a:lnTo>
                  <a:pt x="676" y="791"/>
                </a:lnTo>
                <a:lnTo>
                  <a:pt x="596" y="1071"/>
                </a:lnTo>
                <a:lnTo>
                  <a:pt x="557" y="1071"/>
                </a:lnTo>
                <a:lnTo>
                  <a:pt x="477" y="1071"/>
                </a:lnTo>
                <a:lnTo>
                  <a:pt x="477" y="1117"/>
                </a:lnTo>
                <a:lnTo>
                  <a:pt x="398" y="1210"/>
                </a:lnTo>
                <a:lnTo>
                  <a:pt x="199" y="1303"/>
                </a:lnTo>
                <a:lnTo>
                  <a:pt x="199" y="1397"/>
                </a:lnTo>
                <a:lnTo>
                  <a:pt x="159" y="1397"/>
                </a:lnTo>
                <a:lnTo>
                  <a:pt x="119" y="1397"/>
                </a:lnTo>
                <a:lnTo>
                  <a:pt x="40" y="1490"/>
                </a:lnTo>
                <a:lnTo>
                  <a:pt x="40" y="1536"/>
                </a:lnTo>
                <a:lnTo>
                  <a:pt x="40" y="1583"/>
                </a:lnTo>
                <a:lnTo>
                  <a:pt x="0" y="1630"/>
                </a:lnTo>
              </a:path>
            </a:pathLst>
          </a:custGeom>
          <a:noFill/>
          <a:ln w="15840">
            <a:solidFill>
              <a:srgbClr val="d3ce9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Freeform 41"/>
          <p:cNvSpPr/>
          <p:nvPr/>
        </p:nvSpPr>
        <p:spPr>
          <a:xfrm>
            <a:off x="2997360" y="1687680"/>
            <a:ext cx="2587320" cy="2587320"/>
          </a:xfrm>
          <a:custGeom>
            <a:avLst/>
            <a:gdLst/>
            <a:ahLst/>
            <a:rect l="l" t="t" r="r" b="b"/>
            <a:pathLst>
              <a:path w="1630" h="1630">
                <a:moveTo>
                  <a:pt x="1630" y="0"/>
                </a:moveTo>
                <a:lnTo>
                  <a:pt x="1510" y="140"/>
                </a:lnTo>
                <a:lnTo>
                  <a:pt x="1471" y="140"/>
                </a:lnTo>
                <a:lnTo>
                  <a:pt x="1431" y="140"/>
                </a:lnTo>
                <a:lnTo>
                  <a:pt x="1391" y="140"/>
                </a:lnTo>
                <a:lnTo>
                  <a:pt x="1351" y="140"/>
                </a:lnTo>
                <a:lnTo>
                  <a:pt x="1351" y="186"/>
                </a:lnTo>
                <a:lnTo>
                  <a:pt x="1312" y="186"/>
                </a:lnTo>
                <a:lnTo>
                  <a:pt x="1272" y="186"/>
                </a:lnTo>
                <a:lnTo>
                  <a:pt x="1272" y="233"/>
                </a:lnTo>
                <a:lnTo>
                  <a:pt x="1232" y="233"/>
                </a:lnTo>
                <a:lnTo>
                  <a:pt x="1193" y="233"/>
                </a:lnTo>
                <a:lnTo>
                  <a:pt x="1153" y="233"/>
                </a:lnTo>
                <a:lnTo>
                  <a:pt x="1153" y="279"/>
                </a:lnTo>
                <a:lnTo>
                  <a:pt x="1113" y="279"/>
                </a:lnTo>
                <a:lnTo>
                  <a:pt x="1113" y="326"/>
                </a:lnTo>
                <a:lnTo>
                  <a:pt x="1073" y="326"/>
                </a:lnTo>
                <a:lnTo>
                  <a:pt x="994" y="326"/>
                </a:lnTo>
                <a:lnTo>
                  <a:pt x="954" y="326"/>
                </a:lnTo>
                <a:lnTo>
                  <a:pt x="954" y="372"/>
                </a:lnTo>
                <a:lnTo>
                  <a:pt x="954" y="419"/>
                </a:lnTo>
                <a:lnTo>
                  <a:pt x="914" y="419"/>
                </a:lnTo>
                <a:lnTo>
                  <a:pt x="875" y="465"/>
                </a:lnTo>
                <a:lnTo>
                  <a:pt x="835" y="512"/>
                </a:lnTo>
                <a:lnTo>
                  <a:pt x="795" y="512"/>
                </a:lnTo>
                <a:lnTo>
                  <a:pt x="755" y="512"/>
                </a:lnTo>
                <a:lnTo>
                  <a:pt x="755" y="559"/>
                </a:lnTo>
                <a:lnTo>
                  <a:pt x="755" y="605"/>
                </a:lnTo>
                <a:lnTo>
                  <a:pt x="755" y="652"/>
                </a:lnTo>
                <a:lnTo>
                  <a:pt x="716" y="652"/>
                </a:lnTo>
                <a:lnTo>
                  <a:pt x="676" y="652"/>
                </a:lnTo>
                <a:lnTo>
                  <a:pt x="676" y="698"/>
                </a:lnTo>
                <a:lnTo>
                  <a:pt x="676" y="791"/>
                </a:lnTo>
                <a:lnTo>
                  <a:pt x="636" y="791"/>
                </a:lnTo>
                <a:lnTo>
                  <a:pt x="636" y="838"/>
                </a:lnTo>
                <a:lnTo>
                  <a:pt x="557" y="838"/>
                </a:lnTo>
                <a:lnTo>
                  <a:pt x="517" y="838"/>
                </a:lnTo>
                <a:lnTo>
                  <a:pt x="517" y="884"/>
                </a:lnTo>
                <a:lnTo>
                  <a:pt x="477" y="884"/>
                </a:lnTo>
                <a:lnTo>
                  <a:pt x="477" y="931"/>
                </a:lnTo>
                <a:lnTo>
                  <a:pt x="477" y="977"/>
                </a:lnTo>
                <a:lnTo>
                  <a:pt x="437" y="977"/>
                </a:lnTo>
                <a:lnTo>
                  <a:pt x="437" y="1071"/>
                </a:lnTo>
                <a:lnTo>
                  <a:pt x="437" y="1117"/>
                </a:lnTo>
                <a:lnTo>
                  <a:pt x="437" y="1210"/>
                </a:lnTo>
                <a:lnTo>
                  <a:pt x="398" y="1210"/>
                </a:lnTo>
                <a:lnTo>
                  <a:pt x="358" y="1210"/>
                </a:lnTo>
                <a:lnTo>
                  <a:pt x="318" y="1210"/>
                </a:lnTo>
                <a:lnTo>
                  <a:pt x="278" y="1210"/>
                </a:lnTo>
                <a:lnTo>
                  <a:pt x="239" y="1210"/>
                </a:lnTo>
                <a:lnTo>
                  <a:pt x="239" y="1257"/>
                </a:lnTo>
                <a:lnTo>
                  <a:pt x="199" y="1257"/>
                </a:lnTo>
                <a:lnTo>
                  <a:pt x="199" y="1303"/>
                </a:lnTo>
                <a:lnTo>
                  <a:pt x="199" y="1350"/>
                </a:lnTo>
                <a:lnTo>
                  <a:pt x="159" y="1350"/>
                </a:lnTo>
                <a:lnTo>
                  <a:pt x="119" y="1350"/>
                </a:lnTo>
                <a:lnTo>
                  <a:pt x="80" y="1350"/>
                </a:lnTo>
                <a:lnTo>
                  <a:pt x="40" y="1350"/>
                </a:lnTo>
                <a:lnTo>
                  <a:pt x="40" y="1397"/>
                </a:lnTo>
                <a:lnTo>
                  <a:pt x="0" y="1397"/>
                </a:lnTo>
                <a:lnTo>
                  <a:pt x="0" y="1443"/>
                </a:lnTo>
                <a:lnTo>
                  <a:pt x="0" y="1490"/>
                </a:lnTo>
                <a:lnTo>
                  <a:pt x="0" y="1536"/>
                </a:lnTo>
                <a:lnTo>
                  <a:pt x="0" y="1583"/>
                </a:lnTo>
                <a:lnTo>
                  <a:pt x="0" y="1630"/>
                </a:lnTo>
              </a:path>
            </a:pathLst>
          </a:custGeom>
          <a:noFill/>
          <a:ln w="15840">
            <a:solidFill>
              <a:srgbClr val="7c287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Freeform 42"/>
          <p:cNvSpPr/>
          <p:nvPr/>
        </p:nvSpPr>
        <p:spPr>
          <a:xfrm>
            <a:off x="2997360" y="1687680"/>
            <a:ext cx="2587320" cy="2587320"/>
          </a:xfrm>
          <a:custGeom>
            <a:avLst/>
            <a:gdLst/>
            <a:ahLst/>
            <a:rect l="l" t="t" r="r" b="b"/>
            <a:pathLst>
              <a:path w="1630" h="1630">
                <a:moveTo>
                  <a:pt x="1630" y="0"/>
                </a:moveTo>
                <a:lnTo>
                  <a:pt x="1630" y="46"/>
                </a:lnTo>
                <a:lnTo>
                  <a:pt x="1590" y="46"/>
                </a:lnTo>
                <a:lnTo>
                  <a:pt x="1510" y="46"/>
                </a:lnTo>
                <a:lnTo>
                  <a:pt x="1471" y="46"/>
                </a:lnTo>
                <a:lnTo>
                  <a:pt x="1431" y="140"/>
                </a:lnTo>
                <a:lnTo>
                  <a:pt x="1391" y="140"/>
                </a:lnTo>
                <a:lnTo>
                  <a:pt x="1351" y="140"/>
                </a:lnTo>
                <a:lnTo>
                  <a:pt x="1312" y="140"/>
                </a:lnTo>
                <a:lnTo>
                  <a:pt x="1272" y="140"/>
                </a:lnTo>
                <a:lnTo>
                  <a:pt x="1272" y="186"/>
                </a:lnTo>
                <a:lnTo>
                  <a:pt x="1232" y="233"/>
                </a:lnTo>
                <a:lnTo>
                  <a:pt x="1113" y="279"/>
                </a:lnTo>
                <a:lnTo>
                  <a:pt x="1034" y="279"/>
                </a:lnTo>
                <a:lnTo>
                  <a:pt x="1034" y="326"/>
                </a:lnTo>
                <a:lnTo>
                  <a:pt x="994" y="326"/>
                </a:lnTo>
                <a:lnTo>
                  <a:pt x="954" y="372"/>
                </a:lnTo>
                <a:lnTo>
                  <a:pt x="914" y="372"/>
                </a:lnTo>
                <a:lnTo>
                  <a:pt x="914" y="419"/>
                </a:lnTo>
                <a:lnTo>
                  <a:pt x="835" y="419"/>
                </a:lnTo>
                <a:lnTo>
                  <a:pt x="716" y="745"/>
                </a:lnTo>
                <a:lnTo>
                  <a:pt x="716" y="791"/>
                </a:lnTo>
                <a:lnTo>
                  <a:pt x="676" y="791"/>
                </a:lnTo>
                <a:lnTo>
                  <a:pt x="676" y="838"/>
                </a:lnTo>
                <a:lnTo>
                  <a:pt x="557" y="1071"/>
                </a:lnTo>
                <a:lnTo>
                  <a:pt x="557" y="1117"/>
                </a:lnTo>
                <a:lnTo>
                  <a:pt x="517" y="1117"/>
                </a:lnTo>
                <a:lnTo>
                  <a:pt x="517" y="1164"/>
                </a:lnTo>
                <a:lnTo>
                  <a:pt x="477" y="1210"/>
                </a:lnTo>
                <a:lnTo>
                  <a:pt x="477" y="1303"/>
                </a:lnTo>
                <a:lnTo>
                  <a:pt x="437" y="1350"/>
                </a:lnTo>
                <a:lnTo>
                  <a:pt x="398" y="1350"/>
                </a:lnTo>
                <a:lnTo>
                  <a:pt x="358" y="1350"/>
                </a:lnTo>
                <a:lnTo>
                  <a:pt x="278" y="1443"/>
                </a:lnTo>
                <a:lnTo>
                  <a:pt x="239" y="1443"/>
                </a:lnTo>
                <a:lnTo>
                  <a:pt x="159" y="1443"/>
                </a:lnTo>
                <a:lnTo>
                  <a:pt x="159" y="1490"/>
                </a:lnTo>
                <a:lnTo>
                  <a:pt x="119" y="1490"/>
                </a:lnTo>
                <a:lnTo>
                  <a:pt x="80" y="1536"/>
                </a:lnTo>
                <a:lnTo>
                  <a:pt x="80" y="1630"/>
                </a:lnTo>
                <a:lnTo>
                  <a:pt x="40" y="1630"/>
                </a:lnTo>
                <a:lnTo>
                  <a:pt x="0" y="1630"/>
                </a:lnTo>
              </a:path>
            </a:pathLst>
          </a:custGeom>
          <a:noFill/>
          <a:ln w="15840">
            <a:solidFill>
              <a:srgbClr val="fbf87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46"/>
          <p:cNvSpPr/>
          <p:nvPr/>
        </p:nvSpPr>
        <p:spPr>
          <a:xfrm>
            <a:off x="4226040" y="3495600"/>
            <a:ext cx="129960" cy="0"/>
          </a:xfrm>
          <a:prstGeom prst="line">
            <a:avLst/>
          </a:prstGeom>
          <a:ln w="38160">
            <a:solidFill>
              <a:srgbClr val="3e58a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47"/>
          <p:cNvSpPr/>
          <p:nvPr/>
        </p:nvSpPr>
        <p:spPr>
          <a:xfrm>
            <a:off x="4226040" y="3686040"/>
            <a:ext cx="129960" cy="0"/>
          </a:xfrm>
          <a:prstGeom prst="line">
            <a:avLst/>
          </a:prstGeom>
          <a:ln w="38160">
            <a:solidFill>
              <a:srgbClr val="2eb84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48"/>
          <p:cNvSpPr/>
          <p:nvPr/>
        </p:nvSpPr>
        <p:spPr>
          <a:xfrm>
            <a:off x="4226040" y="3838680"/>
            <a:ext cx="129960" cy="0"/>
          </a:xfrm>
          <a:prstGeom prst="line">
            <a:avLst/>
          </a:prstGeom>
          <a:ln w="38160">
            <a:solidFill>
              <a:srgbClr val="d3ce9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49"/>
          <p:cNvSpPr/>
          <p:nvPr/>
        </p:nvSpPr>
        <p:spPr>
          <a:xfrm>
            <a:off x="4226040" y="3998880"/>
            <a:ext cx="129960" cy="0"/>
          </a:xfrm>
          <a:prstGeom prst="line">
            <a:avLst/>
          </a:prstGeom>
          <a:ln w="38160">
            <a:solidFill>
              <a:srgbClr val="7c287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50"/>
          <p:cNvSpPr/>
          <p:nvPr/>
        </p:nvSpPr>
        <p:spPr>
          <a:xfrm>
            <a:off x="4226040" y="4143240"/>
            <a:ext cx="129960" cy="0"/>
          </a:xfrm>
          <a:prstGeom prst="line">
            <a:avLst/>
          </a:prstGeom>
          <a:ln w="38160">
            <a:solidFill>
              <a:srgbClr val="fbf87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190"/>
          <p:cNvSpPr/>
          <p:nvPr/>
        </p:nvSpPr>
        <p:spPr>
          <a:xfrm>
            <a:off x="2643120" y="4145040"/>
            <a:ext cx="25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191"/>
          <p:cNvSpPr/>
          <p:nvPr/>
        </p:nvSpPr>
        <p:spPr>
          <a:xfrm>
            <a:off x="2526480" y="3622680"/>
            <a:ext cx="375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192"/>
          <p:cNvSpPr/>
          <p:nvPr/>
        </p:nvSpPr>
        <p:spPr>
          <a:xfrm>
            <a:off x="2526480" y="3103560"/>
            <a:ext cx="375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193"/>
          <p:cNvSpPr/>
          <p:nvPr/>
        </p:nvSpPr>
        <p:spPr>
          <a:xfrm>
            <a:off x="2526480" y="2587680"/>
            <a:ext cx="375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194"/>
          <p:cNvSpPr/>
          <p:nvPr/>
        </p:nvSpPr>
        <p:spPr>
          <a:xfrm>
            <a:off x="2526480" y="1558800"/>
            <a:ext cx="375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195"/>
          <p:cNvSpPr/>
          <p:nvPr/>
        </p:nvSpPr>
        <p:spPr>
          <a:xfrm>
            <a:off x="2526480" y="2075040"/>
            <a:ext cx="375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196"/>
          <p:cNvSpPr/>
          <p:nvPr/>
        </p:nvSpPr>
        <p:spPr>
          <a:xfrm rot="10800000">
            <a:off x="2255400" y="2524320"/>
            <a:ext cx="362880" cy="859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Sensitivit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197"/>
          <p:cNvSpPr/>
          <p:nvPr/>
        </p:nvSpPr>
        <p:spPr>
          <a:xfrm>
            <a:off x="2870280" y="4280040"/>
            <a:ext cx="25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198"/>
          <p:cNvSpPr/>
          <p:nvPr/>
        </p:nvSpPr>
        <p:spPr>
          <a:xfrm>
            <a:off x="3330000" y="4278240"/>
            <a:ext cx="375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199"/>
          <p:cNvSpPr/>
          <p:nvPr/>
        </p:nvSpPr>
        <p:spPr>
          <a:xfrm>
            <a:off x="3844080" y="4275000"/>
            <a:ext cx="375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200"/>
          <p:cNvSpPr/>
          <p:nvPr/>
        </p:nvSpPr>
        <p:spPr>
          <a:xfrm>
            <a:off x="4363200" y="4275000"/>
            <a:ext cx="375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201"/>
          <p:cNvSpPr/>
          <p:nvPr/>
        </p:nvSpPr>
        <p:spPr>
          <a:xfrm>
            <a:off x="4877640" y="4275000"/>
            <a:ext cx="375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202"/>
          <p:cNvSpPr/>
          <p:nvPr/>
        </p:nvSpPr>
        <p:spPr>
          <a:xfrm>
            <a:off x="5398560" y="4275000"/>
            <a:ext cx="375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203"/>
          <p:cNvSpPr/>
          <p:nvPr/>
        </p:nvSpPr>
        <p:spPr>
          <a:xfrm rot="16200000">
            <a:off x="4169160" y="4185720"/>
            <a:ext cx="362880" cy="99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1-Specificit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210"/>
          <p:cNvSpPr/>
          <p:nvPr/>
        </p:nvSpPr>
        <p:spPr>
          <a:xfrm>
            <a:off x="4411080" y="3341520"/>
            <a:ext cx="1290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</a:rPr>
              <a:t>S100A6 (AUC: 0.648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211"/>
          <p:cNvSpPr/>
          <p:nvPr/>
        </p:nvSpPr>
        <p:spPr>
          <a:xfrm>
            <a:off x="4412160" y="3538440"/>
            <a:ext cx="1078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</a:rPr>
              <a:t>INR (AUC: 0.669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211"/>
          <p:cNvSpPr/>
          <p:nvPr/>
        </p:nvSpPr>
        <p:spPr>
          <a:xfrm>
            <a:off x="4411800" y="3705120"/>
            <a:ext cx="10861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</a:rPr>
              <a:t>Age (AUC: 0.545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211"/>
          <p:cNvSpPr/>
          <p:nvPr/>
        </p:nvSpPr>
        <p:spPr>
          <a:xfrm>
            <a:off x="4412520" y="3882960"/>
            <a:ext cx="11224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</a:rPr>
              <a:t>CRP (AUC: 0.605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211"/>
          <p:cNvSpPr/>
          <p:nvPr/>
        </p:nvSpPr>
        <p:spPr>
          <a:xfrm>
            <a:off x="4410000" y="4027320"/>
            <a:ext cx="1381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</a:rPr>
              <a:t>creatinine (AUC: 0.560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feld 133"/>
          <p:cNvSpPr/>
          <p:nvPr/>
        </p:nvSpPr>
        <p:spPr>
          <a:xfrm>
            <a:off x="5222880" y="20520"/>
            <a:ext cx="388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Loosen and Benz et al. Supplementary Figure 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3-30T16:54:17Z</dcterms:created>
  <dc:creator>croderburg</dc:creator>
  <dc:description/>
  <dc:language>en-US</dc:language>
  <cp:lastModifiedBy>Sven Loosen</cp:lastModifiedBy>
  <dcterms:modified xsi:type="dcterms:W3CDTF">2016-06-22T09:42:03Z</dcterms:modified>
  <cp:revision>35</cp:revision>
  <dc:subject/>
  <dc:title>Folie 1</dc:title>
</cp:coreProperties>
</file>